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3255E-EFD0-AEBE-FA67-1B081E73F1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8267F6A-30C5-97EC-113B-7AF911CC3E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CFB37F-D62A-4345-9483-CECFDD94F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192B77-D897-503F-3565-EE235088D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712203-2E2A-339E-B81B-446DF4F92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439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441C3F-29AB-A93D-7C72-79FC3A63D7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266320-19F7-C7D0-4DFB-535D535182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D01463-CDDC-D1D1-0F42-9A6F75D18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5233C-BA00-2B2C-C39C-423870685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AC6584-9791-2D98-6767-2FDEC9041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767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1BA076-9736-BDA1-D36A-E6FE944D5E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13F083-2E1A-85EB-1BD5-C1F27E147E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6EDA3-C91C-AEA0-DEC9-0DA34096E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416219-37A1-88B6-F750-AEF8068EB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376F19-BA1A-6ABE-C5D7-4D93B3BE7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062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90CDF-A4B7-3CDF-145F-A5A01A5ABD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A06492-C100-E253-5516-7F5E6B1239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1537FE-67A7-59EB-5DAB-412913B52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2EFAF-275B-3E9F-A673-8CE6E15C4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4BF62-B84A-306F-D50F-D8F8071EC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8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D743B-97D4-5041-9E21-DC72294D16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046AC-9E8A-3B3C-E460-F3C73A7054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8D0BA9-6954-B0E4-1908-D6A1BA7A2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B6046-BF9B-2488-1CD2-0F89DCD5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EC10ED-B502-02DF-F5B9-59EBBCDD2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766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F8D96-F3B5-9D3C-5939-8C20AA3131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22E83-9BE1-7709-B8A6-61B79558F1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974862-DA66-3984-6EC7-28010B038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A74B8D-DF4D-ADF8-AAC8-A4C5CEFBB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F1D5C9-14E5-E6A2-CB5B-192E58EBD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6F6AF7-2B47-4274-3B9B-9C73C01C5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18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B1455-391B-A03E-F737-247891299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45253B-FF87-C991-8999-EB6996267F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0776A8-FBE9-0DA5-79BC-949450F53D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1314F8-AAD1-1688-72EB-F937AF7E31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604A1B-C97C-5B7D-AE5A-B16CF53A52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03C5F2-9011-A4D9-666D-DDFC03474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8BD5A1-1153-F734-DABA-2024D0166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6248F6-45AB-ADB1-1FC3-B7392436B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758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42C25-011F-3403-93F7-FBBF967EF2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159C1F-A7D0-3168-CE06-5FEA7F508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C4E6C7-22B3-09B2-73E2-856F0D6E7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C64CD7-FA19-1F41-1C92-1DE848578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285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B3C18F5-9006-D697-F4FC-25CBB6782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EB4CD8-0D6D-8FE5-AE32-BAF7152FB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DC2319-9104-7910-4722-C321E188F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05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066FB-C2C3-33C6-D5DF-4A3D582C75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4E8609-C4A5-7783-B057-F024F96738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E457D3-8927-6230-A79F-CE3F37F46F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35D256-AE22-F84B-04C3-88F22E6D6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42E004-E713-7803-85B8-3FEB580FC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259579-1096-420A-5F83-8CA574A02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619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A0B705-6FB3-E5DA-8D25-F5123E9BE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6B121F-9EB6-2210-E798-6BE0ACC4D8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70144A-4BDC-87C2-6C4E-6132E8F683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625F0F-4338-09A0-2783-AF32D25A8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782233-2391-B942-E65A-432270625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35D433-4BCE-D847-D6EB-0903987F8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67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1E54E4-192C-EFDC-ACBB-C79E504C6E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D86908-D5D6-BF8A-28FB-2C8FDC9DBE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4975B1-B20E-6102-7A79-596DFA23F2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961867-D648-4C31-87AD-62E6E2E688C4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1C2F3C-4550-8908-BD96-EE8F347F21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7AE9EC-D80C-0477-523F-111F2145A6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7A066C-B85C-4519-84CC-38E9CE4D7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296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screenshot of a graph&#10;&#10;AI-generated content may be incorrect.">
            <a:extLst>
              <a:ext uri="{FF2B5EF4-FFF2-40B4-BE49-F238E27FC236}">
                <a16:creationId xmlns:a16="http://schemas.microsoft.com/office/drawing/2014/main" id="{1F578547-571D-FF7C-CC84-2DFEC82598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0223" y="419577"/>
            <a:ext cx="4749700" cy="4747846"/>
          </a:xfrm>
          <a:prstGeom prst="rect">
            <a:avLst/>
          </a:prstGeom>
        </p:spPr>
      </p:pic>
      <p:sp>
        <p:nvSpPr>
          <p:cNvPr id="7" name="Title 1">
            <a:extLst>
              <a:ext uri="{FF2B5EF4-FFF2-40B4-BE49-F238E27FC236}">
                <a16:creationId xmlns:a16="http://schemas.microsoft.com/office/drawing/2014/main" id="{EC4051DB-8E19-72FA-0D04-F3A7BD658D7D}"/>
              </a:ext>
            </a:extLst>
          </p:cNvPr>
          <p:cNvSpPr txBox="1">
            <a:spLocks/>
          </p:cNvSpPr>
          <p:nvPr/>
        </p:nvSpPr>
        <p:spPr>
          <a:xfrm>
            <a:off x="3722077" y="5167424"/>
            <a:ext cx="4747847" cy="365125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762" b="1">
                <a:latin typeface="Arial" panose="020B0604020202020204" pitchFamily="34" charset="0"/>
                <a:cs typeface="Arial" panose="020B0604020202020204" pitchFamily="34" charset="0"/>
              </a:rPr>
              <a:t>Supplementary Figure S4. Estimated immune cell composition in tumors stratified by EO vs AO CRC in the TCGA dataset. </a:t>
            </a:r>
            <a:r>
              <a:rPr lang="en-US" sz="762">
                <a:latin typeface="Arial" panose="020B0604020202020204" pitchFamily="34" charset="0"/>
                <a:cs typeface="Arial" panose="020B0604020202020204" pitchFamily="34" charset="0"/>
              </a:rPr>
              <a:t>Statistically significant abundances, as determined by t-test and adjusted for multiple comparisons, are shown in the plots. Those without specified p-values were greater than 0.05. 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0DAD8BB4-9587-55FE-0AB7-A85B6A140EE2}"/>
              </a:ext>
            </a:extLst>
          </p:cNvPr>
          <p:cNvSpPr txBox="1">
            <a:spLocks/>
          </p:cNvSpPr>
          <p:nvPr/>
        </p:nvSpPr>
        <p:spPr>
          <a:xfrm>
            <a:off x="3772930" y="215662"/>
            <a:ext cx="4600626" cy="269405"/>
          </a:xfrm>
          <a:prstGeom prst="rect">
            <a:avLst/>
          </a:prstGeom>
        </p:spPr>
        <p:txBody>
          <a:bodyPr vert="horz" lIns="63305" tIns="31652" rIns="63305" bIns="31652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762" b="1">
                <a:latin typeface="Arial" panose="020B0604020202020204" pitchFamily="34" charset="0"/>
                <a:ea typeface="Calibri Light"/>
                <a:cs typeface="Arial" panose="020B0604020202020204" pitchFamily="34" charset="0"/>
              </a:rPr>
              <a:t>TCGA estimated immune abundances</a:t>
            </a:r>
            <a:endParaRPr lang="en-US" sz="762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6463505-4384-087A-73C6-B9303E39A5A0}"/>
              </a:ext>
            </a:extLst>
          </p:cNvPr>
          <p:cNvSpPr txBox="1"/>
          <p:nvPr/>
        </p:nvSpPr>
        <p:spPr>
          <a:xfrm>
            <a:off x="96143" y="57948"/>
            <a:ext cx="28848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Supplementary </a:t>
            </a:r>
            <a:r>
              <a:rPr lang="en-US" sz="1800" b="1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Figure S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101678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8db864bc-821c-4dd3-a9c9-5002b5129ec6}" enabled="1" method="Standard" siteId="{0b95a125-791c-4f0a-9f9e-99e36311750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n, Ning</dc:creator>
  <cp:lastModifiedBy>Dahlberg, Angela</cp:lastModifiedBy>
  <cp:revision>2</cp:revision>
  <dcterms:created xsi:type="dcterms:W3CDTF">2025-09-09T02:40:46Z</dcterms:created>
  <dcterms:modified xsi:type="dcterms:W3CDTF">2025-10-16T20:19:05Z</dcterms:modified>
</cp:coreProperties>
</file>